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60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1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74943" y="1074498"/>
            <a:ext cx="3232001" cy="3353395"/>
            <a:chOff x="11443" y="1349707"/>
            <a:chExt cx="3232001" cy="335339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4484" y="1471003"/>
              <a:ext cx="3108960" cy="312682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865005" y="1349707"/>
              <a:ext cx="210374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IP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20343958">
              <a:off x="1627117" y="4272745"/>
              <a:ext cx="130968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etoclax (nM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3088693">
              <a:off x="-40749" y="3947371"/>
              <a:ext cx="12344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spetinib (nM)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-252945" y="2652783"/>
              <a:ext cx="80577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- score</a:t>
              </a: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3013445" y="1066243"/>
            <a:ext cx="3239751" cy="3370556"/>
            <a:chOff x="2949945" y="1341452"/>
            <a:chExt cx="3239751" cy="3370556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80736" y="1450551"/>
              <a:ext cx="3108960" cy="3064799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20343958">
              <a:off x="4606283" y="4206075"/>
              <a:ext cx="130968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etoclax (nM)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rot="3088693">
              <a:off x="2961913" y="3956277"/>
              <a:ext cx="12344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spetinib (nM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784908" y="1341452"/>
              <a:ext cx="210374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oewe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2685557" y="2675304"/>
              <a:ext cx="80577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- score</a:t>
              </a: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5990524" y="1074498"/>
            <a:ext cx="3265862" cy="3447203"/>
            <a:chOff x="5927024" y="1349707"/>
            <a:chExt cx="3265862" cy="344720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83926" y="1498299"/>
              <a:ext cx="3108960" cy="3117892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 rot="20343958">
              <a:off x="7532827" y="4310701"/>
              <a:ext cx="130968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etoclax (nM)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3088693">
              <a:off x="5963010" y="4041179"/>
              <a:ext cx="12344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spetinib (nM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768819" y="1349707"/>
              <a:ext cx="210374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SA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5662636" y="2713482"/>
              <a:ext cx="80577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- score</a:t>
              </a: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8922449" y="1074499"/>
            <a:ext cx="3223251" cy="3409106"/>
            <a:chOff x="8858949" y="1349708"/>
            <a:chExt cx="3223251" cy="3409106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973240" y="1537316"/>
              <a:ext cx="3108960" cy="3126623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 rot="20343958">
              <a:off x="10459370" y="4285465"/>
              <a:ext cx="130968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etoclax (nM)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3088693">
              <a:off x="8840226" y="4003083"/>
              <a:ext cx="123446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spetinib (nM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9665521" y="1349708"/>
              <a:ext cx="210374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liss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8594561" y="2713481"/>
              <a:ext cx="80577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- score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4216811" y="414789"/>
            <a:ext cx="3820146" cy="686258"/>
            <a:chOff x="4029783" y="5266244"/>
            <a:chExt cx="3820146" cy="686258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73976" y="5329932"/>
              <a:ext cx="3696511" cy="622570"/>
            </a:xfrm>
            <a:prstGeom prst="rect">
              <a:avLst/>
            </a:prstGeom>
          </p:spPr>
        </p:pic>
        <p:sp>
          <p:nvSpPr>
            <p:cNvPr id="42" name="TextBox 41"/>
            <p:cNvSpPr txBox="1"/>
            <p:nvPr/>
          </p:nvSpPr>
          <p:spPr>
            <a:xfrm>
              <a:off x="4029783" y="5266244"/>
              <a:ext cx="3820146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ynergy Score</a:t>
              </a:r>
            </a:p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40     -30     -20    -10       0      10      20      30      40</a:t>
              </a:r>
            </a:p>
          </p:txBody>
        </p:sp>
      </p:grpSp>
      <p:graphicFrame>
        <p:nvGraphicFramePr>
          <p:cNvPr id="45" name="Tab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1551248"/>
              </p:ext>
            </p:extLst>
          </p:nvPr>
        </p:nvGraphicFramePr>
        <p:xfrm>
          <a:off x="3497544" y="4596121"/>
          <a:ext cx="5258680" cy="876300"/>
        </p:xfrm>
        <a:graphic>
          <a:graphicData uri="http://schemas.openxmlformats.org/drawingml/2006/table">
            <a:tbl>
              <a:tblPr/>
              <a:tblGrid>
                <a:gridCol w="1314670">
                  <a:extLst>
                    <a:ext uri="{9D8B030D-6E8A-4147-A177-3AD203B41FA5}">
                      <a16:colId xmlns:a16="http://schemas.microsoft.com/office/drawing/2014/main" val="1611379710"/>
                    </a:ext>
                  </a:extLst>
                </a:gridCol>
                <a:gridCol w="1314670">
                  <a:extLst>
                    <a:ext uri="{9D8B030D-6E8A-4147-A177-3AD203B41FA5}">
                      <a16:colId xmlns:a16="http://schemas.microsoft.com/office/drawing/2014/main" val="4049909976"/>
                    </a:ext>
                  </a:extLst>
                </a:gridCol>
                <a:gridCol w="1314670">
                  <a:extLst>
                    <a:ext uri="{9D8B030D-6E8A-4147-A177-3AD203B41FA5}">
                      <a16:colId xmlns:a16="http://schemas.microsoft.com/office/drawing/2014/main" val="2223503491"/>
                    </a:ext>
                  </a:extLst>
                </a:gridCol>
                <a:gridCol w="1314670">
                  <a:extLst>
                    <a:ext uri="{9D8B030D-6E8A-4147-A177-3AD203B41FA5}">
                      <a16:colId xmlns:a16="http://schemas.microsoft.com/office/drawing/2014/main" val="2460436425"/>
                    </a:ext>
                  </a:extLst>
                </a:gridCol>
              </a:tblGrid>
              <a:tr h="190500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a-DK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spetinib-venetoclax</a:t>
                      </a:r>
                      <a:r>
                        <a:rPr lang="da-DK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a-DK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 scores (</a:t>
                      </a:r>
                      <a:r>
                        <a:rPr lang="el-G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core</a:t>
                      </a:r>
                      <a:r>
                        <a:rPr lang="da-DK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in</a:t>
                      </a:r>
                      <a:r>
                        <a:rPr lang="da-DK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a-DK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-4-11 cells (mean ± SEM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98952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IP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ewe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iss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49107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6 ±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1 ±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 ± 1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448454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00755" y="5923268"/>
            <a:ext cx="11769953" cy="7838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D drug interaction landscapes depicting the interaction between TUS and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netoclax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V-4-11 cells using data averaged from 2 experiments. Table presents mean ± SEM  synergy scores in different models. Note: Synergy scores &lt;-10 indicate antagonism, scores between  -10 and 10 denote additive effects, and &gt;10 predict synergy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5492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15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20</cp:revision>
  <cp:lastPrinted>2024-09-20T16:49:30Z</cp:lastPrinted>
  <dcterms:created xsi:type="dcterms:W3CDTF">2023-07-11T20:23:00Z</dcterms:created>
  <dcterms:modified xsi:type="dcterms:W3CDTF">2024-11-12T02:14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